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  <p:sldId id="258" r:id="rId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36" autoAdjust="0"/>
    <p:restoredTop sz="94660"/>
  </p:normalViewPr>
  <p:slideViewPr>
    <p:cSldViewPr snapToGrid="0">
      <p:cViewPr varScale="1">
        <p:scale>
          <a:sx n="57" d="100"/>
          <a:sy n="57" d="100"/>
        </p:scale>
        <p:origin x="108" y="7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44B2B3B-15F7-F878-0044-7A8AD9F0B94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321D1092-F60C-06E3-DC4F-5B5FBAB279E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7EB1366-9C43-D6FA-D4EE-7FA898DC8C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32F89-D75B-4305-8BA4-60218C783972}" type="datetimeFigureOut">
              <a:rPr kumimoji="1" lang="ja-JP" altLang="en-US" smtClean="0"/>
              <a:t>2025/2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E22966E-06FB-EDDD-88FE-31F2C23BF7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0C5260F-38B1-98A1-7AEE-13D5937378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AAAF9-7D05-415C-9E38-97270DDB40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18249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DC60556-3D5E-6200-7640-025D1FBAD3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89734EE-E552-3F64-D753-2B12CA99CA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3D5AEFF-B42F-D65A-59F8-874A5B7B2F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32F89-D75B-4305-8BA4-60218C783972}" type="datetimeFigureOut">
              <a:rPr kumimoji="1" lang="ja-JP" altLang="en-US" smtClean="0"/>
              <a:t>2025/2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0A889B7-2654-D196-7B5C-52F4BA3096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57D2680-1E5C-9501-48E0-91435B95EA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AAAF9-7D05-415C-9E38-97270DDB40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70410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DF907ED-480E-9144-1218-412C88DFBA6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62CD9A2-8680-77E2-E7C1-6E1F8611C3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7C15842-35C9-4363-2133-E3D6F4F7D0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32F89-D75B-4305-8BA4-60218C783972}" type="datetimeFigureOut">
              <a:rPr kumimoji="1" lang="ja-JP" altLang="en-US" smtClean="0"/>
              <a:t>2025/2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B93F048-A29F-92E0-B96C-79C770D8B5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8EE364F-4DCB-CCAC-0C79-82F7F7CDBE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AAAF9-7D05-415C-9E38-97270DDB40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11709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2D9926F-F118-26C5-36C0-6E410FC69F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1C4B738-33A2-7328-FC31-1F5D53F4221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51E0BB5-D3AE-D984-F702-C232ED2B7D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32F89-D75B-4305-8BA4-60218C783972}" type="datetimeFigureOut">
              <a:rPr kumimoji="1" lang="ja-JP" altLang="en-US" smtClean="0"/>
              <a:t>2025/2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757D66F-7233-5F62-EDDD-2CE1A855A6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F472C33-878F-D8DF-1D2E-EE8BE64907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AAAF9-7D05-415C-9E38-97270DDB40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40625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CC8EBA0-AB89-C95D-02A5-941F397EF4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C22C8A9-087D-4510-16D5-33C0835182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16FB8F9-D318-2C78-DDF8-68BF796F38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32F89-D75B-4305-8BA4-60218C783972}" type="datetimeFigureOut">
              <a:rPr kumimoji="1" lang="ja-JP" altLang="en-US" smtClean="0"/>
              <a:t>2025/2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0AADCC3-BF30-39AF-4B27-F8A00C15CB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7D11F7C-238D-D865-E465-F425A54AC0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AAAF9-7D05-415C-9E38-97270DDB40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66734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0610307-2CFB-4DB7-25E6-574E607DD6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1DA2039-9C29-BA73-2522-0F21C6DFE41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070B996-78BF-BF22-8041-F468AFDFF7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E782DBA-1601-66A0-C1F2-78EFA38215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32F89-D75B-4305-8BA4-60218C783972}" type="datetimeFigureOut">
              <a:rPr kumimoji="1" lang="ja-JP" altLang="en-US" smtClean="0"/>
              <a:t>2025/2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4C63073-663B-BAEA-B899-F6E5C7214D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95268C4-82FC-978A-C5F8-D68587BE7C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AAAF9-7D05-415C-9E38-97270DDB40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99475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B14BD3B-EEC5-F8C9-5FD0-47CDCF700A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677DD4C-12D5-24C0-41DE-931637F910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4F5BF66-1A80-E209-601E-E63D298679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35B60041-C8C6-F674-8346-9489B4C5D34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22D96D1B-AA71-AE81-030E-72698EF70E9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E5B13F05-0B4B-EC34-6F73-5C2A3D6FCF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32F89-D75B-4305-8BA4-60218C783972}" type="datetimeFigureOut">
              <a:rPr kumimoji="1" lang="ja-JP" altLang="en-US" smtClean="0"/>
              <a:t>2025/2/1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D22AE254-4D6C-1A57-8920-FFF7C5B080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6699EF4-AA89-916E-F8C3-60CBFC12EB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AAAF9-7D05-415C-9E38-97270DDB40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49392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0B4EB69-170E-720C-16FF-7FE9FC3D53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908D8B0E-002C-75A5-68C0-853C9A3A23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32F89-D75B-4305-8BA4-60218C783972}" type="datetimeFigureOut">
              <a:rPr kumimoji="1" lang="ja-JP" altLang="en-US" smtClean="0"/>
              <a:t>2025/2/1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CC78193-54BF-08E2-CBF9-8C0DA7D88C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C1FBC9C-BC98-B779-4579-84237DC916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AAAF9-7D05-415C-9E38-97270DDB40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33506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7F076C5-0023-9741-9252-553AC8DE81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32F89-D75B-4305-8BA4-60218C783972}" type="datetimeFigureOut">
              <a:rPr kumimoji="1" lang="ja-JP" altLang="en-US" smtClean="0"/>
              <a:t>2025/2/1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3D92882E-482F-A9FD-6213-905324501B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AC22EEC-86BA-81B2-3B7A-4AB9CBFE2D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AAAF9-7D05-415C-9E38-97270DDB40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67304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F3C48B5-83A7-2F18-2738-E443A249E4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F955A1B-36C9-08B6-DD22-F5D5528E2FA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013C07A-5A35-9063-78C5-DCB8E093F5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F642E54-DC7B-4646-876B-9F4663EC7A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32F89-D75B-4305-8BA4-60218C783972}" type="datetimeFigureOut">
              <a:rPr kumimoji="1" lang="ja-JP" altLang="en-US" smtClean="0"/>
              <a:t>2025/2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72BDF02-FD7A-FEF5-AC5A-21BBE692DD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3F2B875-C6A1-9DD4-CBC3-305330926D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AAAF9-7D05-415C-9E38-97270DDB40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09594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6CED249-FA73-5E71-E4D6-FC6B1C9687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2451CCD-BA88-8156-E1C6-573DCA2B758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AC9B869-BAF2-47CA-FA3A-C82BF4BF5C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348C0E1-D01C-7322-A984-F2F4137D5B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32F89-D75B-4305-8BA4-60218C783972}" type="datetimeFigureOut">
              <a:rPr kumimoji="1" lang="ja-JP" altLang="en-US" smtClean="0"/>
              <a:t>2025/2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597CC50-29A8-1FEE-B06A-4152CFCBEC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9113010-5967-A4F7-06A3-D8D477CC01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AAAF9-7D05-415C-9E38-97270DDB40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99945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C7E6BEE-0C4A-0A21-3232-802448DFD8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50120A5-5E59-3B2B-3B71-3935068ADB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C82649E-A7C2-F85E-4F84-B8FCFAF833F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C32F89-D75B-4305-8BA4-60218C783972}" type="datetimeFigureOut">
              <a:rPr kumimoji="1" lang="ja-JP" altLang="en-US" smtClean="0"/>
              <a:t>2025/2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C14E577-CB4E-5015-ECD8-02E6FA96558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893FD4A-A9F2-29B5-30FE-668FD3834C8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DAAAF9-7D05-415C-9E38-97270DDB40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14152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7140C3E3-C100-1725-C70C-52BE7A059F5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24336" y="42492"/>
            <a:ext cx="6462242" cy="6773015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D930487-6489-5A4E-C4AE-8FB3366ED1B4}"/>
              </a:ext>
            </a:extLst>
          </p:cNvPr>
          <p:cNvSpPr txBox="1"/>
          <p:nvPr/>
        </p:nvSpPr>
        <p:spPr>
          <a:xfrm>
            <a:off x="3342978" y="0"/>
            <a:ext cx="5943600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ja-JP" altLang="en-US" sz="3200" dirty="0">
                <a:latin typeface="Arial" panose="020B0604020202020204" pitchFamily="34" charset="0"/>
                <a:cs typeface="Arial" panose="020B0604020202020204" pitchFamily="34" charset="0"/>
              </a:rPr>
              <a:t>　　</a:t>
            </a:r>
            <a:r>
              <a:rPr kumimoji="1" lang="en-US" altLang="ja-JP" sz="3200" dirty="0">
                <a:latin typeface="Arial" panose="020B0604020202020204" pitchFamily="34" charset="0"/>
                <a:cs typeface="Arial" panose="020B0604020202020204" pitchFamily="34" charset="0"/>
              </a:rPr>
              <a:t>ROC curve : Category 1</a:t>
            </a:r>
            <a:endParaRPr kumimoji="1" lang="ja-JP" altLang="en-US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99014E3-AC17-A1BB-E4DA-2C4F02F1BC8F}"/>
              </a:ext>
            </a:extLst>
          </p:cNvPr>
          <p:cNvSpPr txBox="1"/>
          <p:nvPr/>
        </p:nvSpPr>
        <p:spPr>
          <a:xfrm flipV="1">
            <a:off x="2569687" y="2603500"/>
            <a:ext cx="553998" cy="1651000"/>
          </a:xfrm>
          <a:prstGeom prst="rect">
            <a:avLst/>
          </a:prstGeom>
          <a:solidFill>
            <a:schemeClr val="bg1"/>
          </a:solidFill>
        </p:spPr>
        <p:txBody>
          <a:bodyPr vert="eaVert" wrap="squar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Sensitivity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E8D1D2B-924E-90CF-5A89-CB29DD69D8F8}"/>
              </a:ext>
            </a:extLst>
          </p:cNvPr>
          <p:cNvSpPr txBox="1"/>
          <p:nvPr/>
        </p:nvSpPr>
        <p:spPr>
          <a:xfrm>
            <a:off x="5469467" y="6396335"/>
            <a:ext cx="1571264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Specificity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95106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BCD9A933-7395-D6F8-9CEE-6B141427BF0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05391" y="76200"/>
            <a:ext cx="6581218" cy="6688667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47AA890-69C0-ABFA-1861-AC310F4452C3}"/>
              </a:ext>
            </a:extLst>
          </p:cNvPr>
          <p:cNvSpPr txBox="1"/>
          <p:nvPr/>
        </p:nvSpPr>
        <p:spPr>
          <a:xfrm flipV="1">
            <a:off x="2603553" y="2603500"/>
            <a:ext cx="553998" cy="1651000"/>
          </a:xfrm>
          <a:prstGeom prst="rect">
            <a:avLst/>
          </a:prstGeom>
          <a:solidFill>
            <a:schemeClr val="bg1"/>
          </a:solidFill>
        </p:spPr>
        <p:txBody>
          <a:bodyPr vert="eaVert" wrap="squar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Sensitivity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E635AE3-9765-F59F-219C-B2877DA99881}"/>
              </a:ext>
            </a:extLst>
          </p:cNvPr>
          <p:cNvSpPr txBox="1"/>
          <p:nvPr/>
        </p:nvSpPr>
        <p:spPr>
          <a:xfrm>
            <a:off x="5469467" y="6396335"/>
            <a:ext cx="1571264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Specificity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CF32F8F-F26F-FA01-6569-BB5912BEB109}"/>
              </a:ext>
            </a:extLst>
          </p:cNvPr>
          <p:cNvSpPr txBox="1"/>
          <p:nvPr/>
        </p:nvSpPr>
        <p:spPr>
          <a:xfrm>
            <a:off x="3342978" y="0"/>
            <a:ext cx="5943600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ja-JP" altLang="en-US" sz="3200" dirty="0">
                <a:latin typeface="Arial" panose="020B0604020202020204" pitchFamily="34" charset="0"/>
                <a:cs typeface="Arial" panose="020B0604020202020204" pitchFamily="34" charset="0"/>
              </a:rPr>
              <a:t>　　</a:t>
            </a:r>
            <a:r>
              <a:rPr kumimoji="1" lang="en-US" altLang="ja-JP" sz="3200" dirty="0">
                <a:latin typeface="Arial" panose="020B0604020202020204" pitchFamily="34" charset="0"/>
                <a:cs typeface="Arial" panose="020B0604020202020204" pitchFamily="34" charset="0"/>
              </a:rPr>
              <a:t>ROC curve : Category 2</a:t>
            </a:r>
            <a:endParaRPr kumimoji="1" lang="ja-JP" altLang="en-US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168656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F6FE8587-4410-0E27-E295-A1DC0219A4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88980" y="0"/>
            <a:ext cx="6614039" cy="685800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979A916-6932-9CBF-519A-B333F2AC5A50}"/>
              </a:ext>
            </a:extLst>
          </p:cNvPr>
          <p:cNvSpPr txBox="1"/>
          <p:nvPr/>
        </p:nvSpPr>
        <p:spPr>
          <a:xfrm>
            <a:off x="5469467" y="6396335"/>
            <a:ext cx="1571264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Specificity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16AD774-1943-6728-68AB-4A940DADB81B}"/>
              </a:ext>
            </a:extLst>
          </p:cNvPr>
          <p:cNvSpPr txBox="1"/>
          <p:nvPr/>
        </p:nvSpPr>
        <p:spPr>
          <a:xfrm flipV="1">
            <a:off x="2755114" y="2603500"/>
            <a:ext cx="553998" cy="1651000"/>
          </a:xfrm>
          <a:prstGeom prst="rect">
            <a:avLst/>
          </a:prstGeom>
          <a:solidFill>
            <a:schemeClr val="bg1"/>
          </a:solidFill>
        </p:spPr>
        <p:txBody>
          <a:bodyPr vert="eaVert" wrap="squar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Sensitivity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83243A1-30E6-9471-36B8-1B9AA5ED1A06}"/>
              </a:ext>
            </a:extLst>
          </p:cNvPr>
          <p:cNvSpPr txBox="1"/>
          <p:nvPr/>
        </p:nvSpPr>
        <p:spPr>
          <a:xfrm>
            <a:off x="3342978" y="0"/>
            <a:ext cx="5943600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ja-JP" altLang="en-US" sz="3200" dirty="0">
                <a:latin typeface="Arial" panose="020B0604020202020204" pitchFamily="34" charset="0"/>
                <a:cs typeface="Arial" panose="020B0604020202020204" pitchFamily="34" charset="0"/>
              </a:rPr>
              <a:t>　　</a:t>
            </a:r>
            <a:r>
              <a:rPr kumimoji="1" lang="en-US" altLang="ja-JP" sz="3200" dirty="0">
                <a:latin typeface="Arial" panose="020B0604020202020204" pitchFamily="34" charset="0"/>
                <a:cs typeface="Arial" panose="020B0604020202020204" pitchFamily="34" charset="0"/>
              </a:rPr>
              <a:t>ROC curve : Category 3</a:t>
            </a:r>
            <a:endParaRPr kumimoji="1" lang="ja-JP" altLang="en-US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23644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24</Words>
  <Application>Microsoft Office PowerPoint</Application>
  <PresentationFormat>ワイド画面</PresentationFormat>
  <Paragraphs>9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7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陽子 中沢</dc:creator>
  <cp:lastModifiedBy>陽子 中沢</cp:lastModifiedBy>
  <cp:revision>5</cp:revision>
  <dcterms:created xsi:type="dcterms:W3CDTF">2025-02-16T10:56:56Z</dcterms:created>
  <dcterms:modified xsi:type="dcterms:W3CDTF">2025-02-16T12:10:33Z</dcterms:modified>
</cp:coreProperties>
</file>